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2C8503-C43E-94CC-6B2A-DAA1A4999F03}" name="Keane, Sean T" initials="SK" userId="S::skeane1@ic.ac.uk::4b207843-03b2-4fe5-b9e3-eab1bfb1e984" providerId="AD"/>
  <p188:author id="{25965566-DCB8-5FB7-0D4C-B52D2E943281}" name="Fulton, William T J" initials="FJ" userId="S::wfulton@ic.ac.uk::4d291324-378e-4ad8-aeb6-9357da62268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DD6C6D-7436-E74D-BB67-A38DEBBAC688}" v="5" dt="2026-02-02T16:38:43.458"/>
  </p1510:revLst>
</p1510:revInfo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–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03"/>
    <p:restoredTop sz="94660"/>
  </p:normalViewPr>
  <p:slideViewPr>
    <p:cSldViewPr snapToGrid="0">
      <p:cViewPr varScale="1">
        <p:scale>
          <a:sx n="82" d="100"/>
          <a:sy n="82" d="100"/>
        </p:scale>
        <p:origin x="34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, Jooeun" userId="74932ba8-99c8-451f-9254-5909a1211fe7" providerId="ADAL" clId="{CD52A289-8FB7-5040-AC61-F2B49A34DC14}"/>
    <pc:docChg chg="modSld">
      <pc:chgData name="Han, Jooeun" userId="74932ba8-99c8-451f-9254-5909a1211fe7" providerId="ADAL" clId="{CD52A289-8FB7-5040-AC61-F2B49A34DC14}" dt="2026-01-26T16:03:14.594" v="9" actId="1076"/>
      <pc:docMkLst>
        <pc:docMk/>
      </pc:docMkLst>
      <pc:sldChg chg="addSp modSp mod">
        <pc:chgData name="Han, Jooeun" userId="74932ba8-99c8-451f-9254-5909a1211fe7" providerId="ADAL" clId="{CD52A289-8FB7-5040-AC61-F2B49A34DC14}" dt="2026-01-26T16:03:14.594" v="9" actId="1076"/>
        <pc:sldMkLst>
          <pc:docMk/>
          <pc:sldMk cId="3578941364" sldId="272"/>
        </pc:sldMkLst>
        <pc:spChg chg="mod">
          <ac:chgData name="Han, Jooeun" userId="74932ba8-99c8-451f-9254-5909a1211fe7" providerId="ADAL" clId="{CD52A289-8FB7-5040-AC61-F2B49A34DC14}" dt="2026-01-26T16:02:52.873" v="0"/>
          <ac:spMkLst>
            <pc:docMk/>
            <pc:sldMk cId="3578941364" sldId="272"/>
            <ac:spMk id="3" creationId="{D29C5EDC-582E-4232-31A3-C8AB6208EEF8}"/>
          </ac:spMkLst>
        </pc:spChg>
        <pc:spChg chg="mod">
          <ac:chgData name="Han, Jooeun" userId="74932ba8-99c8-451f-9254-5909a1211fe7" providerId="ADAL" clId="{CD52A289-8FB7-5040-AC61-F2B49A34DC14}" dt="2026-01-26T16:02:52.873" v="0"/>
          <ac:spMkLst>
            <pc:docMk/>
            <pc:sldMk cId="3578941364" sldId="272"/>
            <ac:spMk id="5" creationId="{37C89E6F-7E38-44B0-DC01-8F69E6F65136}"/>
          </ac:spMkLst>
        </pc:spChg>
        <pc:spChg chg="mod">
          <ac:chgData name="Han, Jooeun" userId="74932ba8-99c8-451f-9254-5909a1211fe7" providerId="ADAL" clId="{CD52A289-8FB7-5040-AC61-F2B49A34DC14}" dt="2026-01-26T16:02:58.714" v="2"/>
          <ac:spMkLst>
            <pc:docMk/>
            <pc:sldMk cId="3578941364" sldId="272"/>
            <ac:spMk id="8" creationId="{595C64E0-59F9-6629-3251-44FB528112BB}"/>
          </ac:spMkLst>
        </pc:spChg>
        <pc:spChg chg="mod">
          <ac:chgData name="Han, Jooeun" userId="74932ba8-99c8-451f-9254-5909a1211fe7" providerId="ADAL" clId="{CD52A289-8FB7-5040-AC61-F2B49A34DC14}" dt="2026-01-26T16:02:58.714" v="2"/>
          <ac:spMkLst>
            <pc:docMk/>
            <pc:sldMk cId="3578941364" sldId="272"/>
            <ac:spMk id="12" creationId="{1F3C7A70-CF6C-2352-08A1-9C511CFF85EE}"/>
          </ac:spMkLst>
        </pc:spChg>
        <pc:spChg chg="mod">
          <ac:chgData name="Han, Jooeun" userId="74932ba8-99c8-451f-9254-5909a1211fe7" providerId="ADAL" clId="{CD52A289-8FB7-5040-AC61-F2B49A34DC14}" dt="2026-01-26T16:03:08.023" v="6"/>
          <ac:spMkLst>
            <pc:docMk/>
            <pc:sldMk cId="3578941364" sldId="272"/>
            <ac:spMk id="16" creationId="{74C316E8-25AD-F089-D246-AB64B3576892}"/>
          </ac:spMkLst>
        </pc:spChg>
        <pc:spChg chg="mod">
          <ac:chgData name="Han, Jooeun" userId="74932ba8-99c8-451f-9254-5909a1211fe7" providerId="ADAL" clId="{CD52A289-8FB7-5040-AC61-F2B49A34DC14}" dt="2026-01-26T16:03:08.023" v="6"/>
          <ac:spMkLst>
            <pc:docMk/>
            <pc:sldMk cId="3578941364" sldId="272"/>
            <ac:spMk id="18" creationId="{49824C5A-B99E-7438-D02A-6E512902A689}"/>
          </ac:spMkLst>
        </pc:spChg>
        <pc:spChg chg="mod">
          <ac:chgData name="Han, Jooeun" userId="74932ba8-99c8-451f-9254-5909a1211fe7" providerId="ADAL" clId="{CD52A289-8FB7-5040-AC61-F2B49A34DC14}" dt="2026-01-26T16:03:10.807" v="8"/>
          <ac:spMkLst>
            <pc:docMk/>
            <pc:sldMk cId="3578941364" sldId="272"/>
            <ac:spMk id="21" creationId="{A61AF4BC-7805-5824-F11B-6DBA2A00D8C6}"/>
          </ac:spMkLst>
        </pc:spChg>
        <pc:spChg chg="mod">
          <ac:chgData name="Han, Jooeun" userId="74932ba8-99c8-451f-9254-5909a1211fe7" providerId="ADAL" clId="{CD52A289-8FB7-5040-AC61-F2B49A34DC14}" dt="2026-01-26T16:03:10.807" v="8"/>
          <ac:spMkLst>
            <pc:docMk/>
            <pc:sldMk cId="3578941364" sldId="272"/>
            <ac:spMk id="68" creationId="{47D9B71D-3FA1-DAF6-A434-A8975702FC93}"/>
          </ac:spMkLst>
        </pc:spChg>
        <pc:grpChg chg="add mod">
          <ac:chgData name="Han, Jooeun" userId="74932ba8-99c8-451f-9254-5909a1211fe7" providerId="ADAL" clId="{CD52A289-8FB7-5040-AC61-F2B49A34DC14}" dt="2026-01-26T16:03:07.706" v="5" actId="1076"/>
          <ac:grpSpMkLst>
            <pc:docMk/>
            <pc:sldMk cId="3578941364" sldId="272"/>
            <ac:grpSpMk id="7" creationId="{E5605ED8-2D09-A3C5-1E8C-56AECF6DC13E}"/>
          </ac:grpSpMkLst>
        </pc:grpChg>
        <pc:grpChg chg="add mod">
          <ac:chgData name="Han, Jooeun" userId="74932ba8-99c8-451f-9254-5909a1211fe7" providerId="ADAL" clId="{CD52A289-8FB7-5040-AC61-F2B49A34DC14}" dt="2026-01-26T16:03:10.417" v="7" actId="1076"/>
          <ac:grpSpMkLst>
            <pc:docMk/>
            <pc:sldMk cId="3578941364" sldId="272"/>
            <ac:grpSpMk id="14" creationId="{BD8AB6C0-53F1-86A3-A4D7-7D08D70FA560}"/>
          </ac:grpSpMkLst>
        </pc:grpChg>
        <pc:grpChg chg="add mod">
          <ac:chgData name="Han, Jooeun" userId="74932ba8-99c8-451f-9254-5909a1211fe7" providerId="ADAL" clId="{CD52A289-8FB7-5040-AC61-F2B49A34DC14}" dt="2026-01-26T16:03:14.594" v="9" actId="1076"/>
          <ac:grpSpMkLst>
            <pc:docMk/>
            <pc:sldMk cId="3578941364" sldId="272"/>
            <ac:grpSpMk id="19" creationId="{65A92DFD-33CE-0DB5-2675-4CF4AA221C83}"/>
          </ac:grpSpMkLst>
        </pc:grpChg>
      </pc:sldChg>
    </pc:docChg>
  </pc:docChgLst>
  <pc:docChgLst>
    <pc:chgData name="Layhadi, Janice A" userId="0a2e9531-7ec3-43d3-86a3-b0f00bbdd07c" providerId="ADAL" clId="{77757C92-1BF6-5290-B4EA-2BF7C0CA941C}"/>
    <pc:docChg chg="custSel modSld">
      <pc:chgData name="Layhadi, Janice A" userId="0a2e9531-7ec3-43d3-86a3-b0f00bbdd07c" providerId="ADAL" clId="{77757C92-1BF6-5290-B4EA-2BF7C0CA941C}" dt="2026-02-02T16:38:43.458" v="54" actId="164"/>
      <pc:docMkLst>
        <pc:docMk/>
      </pc:docMkLst>
      <pc:sldChg chg="addSp delSp modSp mod">
        <pc:chgData name="Layhadi, Janice A" userId="0a2e9531-7ec3-43d3-86a3-b0f00bbdd07c" providerId="ADAL" clId="{77757C92-1BF6-5290-B4EA-2BF7C0CA941C}" dt="2026-02-02T16:38:43.458" v="54" actId="164"/>
        <pc:sldMkLst>
          <pc:docMk/>
          <pc:sldMk cId="3578941364" sldId="272"/>
        </pc:sldMkLst>
        <pc:spChg chg="mod">
          <ac:chgData name="Layhadi, Janice A" userId="0a2e9531-7ec3-43d3-86a3-b0f00bbdd07c" providerId="ADAL" clId="{77757C92-1BF6-5290-B4EA-2BF7C0CA941C}" dt="2026-02-02T16:37:31.238" v="1" actId="114"/>
          <ac:spMkLst>
            <pc:docMk/>
            <pc:sldMk cId="3578941364" sldId="272"/>
            <ac:spMk id="9" creationId="{404E574E-5209-0323-A026-D69F0E01DF21}"/>
          </ac:spMkLst>
        </pc:spChg>
        <pc:spChg chg="add mod">
          <ac:chgData name="Layhadi, Janice A" userId="0a2e9531-7ec3-43d3-86a3-b0f00bbdd07c" providerId="ADAL" clId="{77757C92-1BF6-5290-B4EA-2BF7C0CA941C}" dt="2026-02-02T16:38:39.363" v="53" actId="164"/>
          <ac:spMkLst>
            <pc:docMk/>
            <pc:sldMk cId="3578941364" sldId="272"/>
            <ac:spMk id="69" creationId="{9BF09CFA-E68E-DE04-22D0-D698969AB4CD}"/>
          </ac:spMkLst>
        </pc:spChg>
        <pc:spChg chg="add mod">
          <ac:chgData name="Layhadi, Janice A" userId="0a2e9531-7ec3-43d3-86a3-b0f00bbdd07c" providerId="ADAL" clId="{77757C92-1BF6-5290-B4EA-2BF7C0CA941C}" dt="2026-02-02T16:38:39.363" v="53" actId="164"/>
          <ac:spMkLst>
            <pc:docMk/>
            <pc:sldMk cId="3578941364" sldId="272"/>
            <ac:spMk id="70" creationId="{3434AD2C-E8DA-FF52-C117-4AB3F0B40AFC}"/>
          </ac:spMkLst>
        </pc:spChg>
        <pc:spChg chg="add mod">
          <ac:chgData name="Layhadi, Janice A" userId="0a2e9531-7ec3-43d3-86a3-b0f00bbdd07c" providerId="ADAL" clId="{77757C92-1BF6-5290-B4EA-2BF7C0CA941C}" dt="2026-02-02T16:38:43.458" v="54" actId="164"/>
          <ac:spMkLst>
            <pc:docMk/>
            <pc:sldMk cId="3578941364" sldId="272"/>
            <ac:spMk id="71" creationId="{176F4CC5-A765-FC3C-2AB6-6D31A1DBAD54}"/>
          </ac:spMkLst>
        </pc:spChg>
        <pc:spChg chg="add mod">
          <ac:chgData name="Layhadi, Janice A" userId="0a2e9531-7ec3-43d3-86a3-b0f00bbdd07c" providerId="ADAL" clId="{77757C92-1BF6-5290-B4EA-2BF7C0CA941C}" dt="2026-02-02T16:38:43.458" v="54" actId="164"/>
          <ac:spMkLst>
            <pc:docMk/>
            <pc:sldMk cId="3578941364" sldId="272"/>
            <ac:spMk id="72" creationId="{06917CC5-746C-D3BC-3A5D-D0ABC9E28CC2}"/>
          </ac:spMkLst>
        </pc:spChg>
        <pc:grpChg chg="del">
          <ac:chgData name="Layhadi, Janice A" userId="0a2e9531-7ec3-43d3-86a3-b0f00bbdd07c" providerId="ADAL" clId="{77757C92-1BF6-5290-B4EA-2BF7C0CA941C}" dt="2026-02-02T16:37:32.780" v="2" actId="478"/>
          <ac:grpSpMkLst>
            <pc:docMk/>
            <pc:sldMk cId="3578941364" sldId="272"/>
            <ac:grpSpMk id="2" creationId="{B664C4FF-9837-8957-B5B7-BF37C8C7FACC}"/>
          </ac:grpSpMkLst>
        </pc:grpChg>
        <pc:grpChg chg="del">
          <ac:chgData name="Layhadi, Janice A" userId="0a2e9531-7ec3-43d3-86a3-b0f00bbdd07c" providerId="ADAL" clId="{77757C92-1BF6-5290-B4EA-2BF7C0CA941C}" dt="2026-02-02T16:37:42.328" v="7" actId="478"/>
          <ac:grpSpMkLst>
            <pc:docMk/>
            <pc:sldMk cId="3578941364" sldId="272"/>
            <ac:grpSpMk id="7" creationId="{E5605ED8-2D09-A3C5-1E8C-56AECF6DC13E}"/>
          </ac:grpSpMkLst>
        </pc:grpChg>
        <pc:grpChg chg="del">
          <ac:chgData name="Layhadi, Janice A" userId="0a2e9531-7ec3-43d3-86a3-b0f00bbdd07c" providerId="ADAL" clId="{77757C92-1BF6-5290-B4EA-2BF7C0CA941C}" dt="2026-02-02T16:37:40.535" v="6" actId="478"/>
          <ac:grpSpMkLst>
            <pc:docMk/>
            <pc:sldMk cId="3578941364" sldId="272"/>
            <ac:grpSpMk id="14" creationId="{BD8AB6C0-53F1-86A3-A4D7-7D08D70FA560}"/>
          </ac:grpSpMkLst>
        </pc:grpChg>
        <pc:grpChg chg="del">
          <ac:chgData name="Layhadi, Janice A" userId="0a2e9531-7ec3-43d3-86a3-b0f00bbdd07c" providerId="ADAL" clId="{77757C92-1BF6-5290-B4EA-2BF7C0CA941C}" dt="2026-02-02T16:37:36.021" v="3" actId="478"/>
          <ac:grpSpMkLst>
            <pc:docMk/>
            <pc:sldMk cId="3578941364" sldId="272"/>
            <ac:grpSpMk id="19" creationId="{65A92DFD-33CE-0DB5-2675-4CF4AA221C83}"/>
          </ac:grpSpMkLst>
        </pc:grpChg>
        <pc:grpChg chg="add mod">
          <ac:chgData name="Layhadi, Janice A" userId="0a2e9531-7ec3-43d3-86a3-b0f00bbdd07c" providerId="ADAL" clId="{77757C92-1BF6-5290-B4EA-2BF7C0CA941C}" dt="2026-02-02T16:38:39.363" v="53" actId="164"/>
          <ac:grpSpMkLst>
            <pc:docMk/>
            <pc:sldMk cId="3578941364" sldId="272"/>
            <ac:grpSpMk id="73" creationId="{9D1E04BF-AB37-1B72-8C43-112F8D6547FF}"/>
          </ac:grpSpMkLst>
        </pc:grpChg>
        <pc:grpChg chg="add mod">
          <ac:chgData name="Layhadi, Janice A" userId="0a2e9531-7ec3-43d3-86a3-b0f00bbdd07c" providerId="ADAL" clId="{77757C92-1BF6-5290-B4EA-2BF7C0CA941C}" dt="2026-02-02T16:38:43.458" v="54" actId="164"/>
          <ac:grpSpMkLst>
            <pc:docMk/>
            <pc:sldMk cId="3578941364" sldId="272"/>
            <ac:grpSpMk id="74" creationId="{22215910-669C-7611-6A66-F44E15F566AB}"/>
          </ac:grpSpMkLst>
        </pc:grpChg>
        <pc:graphicFrameChg chg="modGraphic">
          <ac:chgData name="Layhadi, Janice A" userId="0a2e9531-7ec3-43d3-86a3-b0f00bbdd07c" providerId="ADAL" clId="{77757C92-1BF6-5290-B4EA-2BF7C0CA941C}" dt="2026-02-02T16:37:37.964" v="5" actId="114"/>
          <ac:graphicFrameMkLst>
            <pc:docMk/>
            <pc:sldMk cId="3578941364" sldId="272"/>
            <ac:graphicFrameMk id="53" creationId="{5F9B3544-008B-D3C6-F74E-32366FDAA3B9}"/>
          </ac:graphicFrameMkLst>
        </pc:graphicFrameChg>
        <pc:picChg chg="mod modCrop">
          <ac:chgData name="Layhadi, Janice A" userId="0a2e9531-7ec3-43d3-86a3-b0f00bbdd07c" providerId="ADAL" clId="{77757C92-1BF6-5290-B4EA-2BF7C0CA941C}" dt="2026-02-02T16:38:39.363" v="53" actId="164"/>
          <ac:picMkLst>
            <pc:docMk/>
            <pc:sldMk cId="3578941364" sldId="272"/>
            <ac:picMk id="51" creationId="{1D7A4CB7-EC27-1760-4963-58C5CC60F90F}"/>
          </ac:picMkLst>
        </pc:picChg>
        <pc:picChg chg="mod modCrop">
          <ac:chgData name="Layhadi, Janice A" userId="0a2e9531-7ec3-43d3-86a3-b0f00bbdd07c" providerId="ADAL" clId="{77757C92-1BF6-5290-B4EA-2BF7C0CA941C}" dt="2026-02-02T16:38:43.458" v="54" actId="164"/>
          <ac:picMkLst>
            <pc:docMk/>
            <pc:sldMk cId="3578941364" sldId="272"/>
            <ac:picMk id="52" creationId="{0EEDB0D0-1BEF-D362-821A-48A5437977E0}"/>
          </ac:picMkLst>
        </pc:picChg>
        <pc:cxnChg chg="mod">
          <ac:chgData name="Layhadi, Janice A" userId="0a2e9531-7ec3-43d3-86a3-b0f00bbdd07c" providerId="ADAL" clId="{77757C92-1BF6-5290-B4EA-2BF7C0CA941C}" dt="2026-02-02T16:38:39.363" v="53" actId="164"/>
          <ac:cxnSpMkLst>
            <pc:docMk/>
            <pc:sldMk cId="3578941364" sldId="272"/>
            <ac:cxnSpMk id="40" creationId="{A9F6E0EA-4D50-3762-8CB3-C9EAE1652D2C}"/>
          </ac:cxnSpMkLst>
        </pc:cxnChg>
        <pc:cxnChg chg="mod">
          <ac:chgData name="Layhadi, Janice A" userId="0a2e9531-7ec3-43d3-86a3-b0f00bbdd07c" providerId="ADAL" clId="{77757C92-1BF6-5290-B4EA-2BF7C0CA941C}" dt="2026-02-02T16:38:39.363" v="53" actId="164"/>
          <ac:cxnSpMkLst>
            <pc:docMk/>
            <pc:sldMk cId="3578941364" sldId="272"/>
            <ac:cxnSpMk id="43" creationId="{1301B1D4-8B44-A768-1416-7CF5F1DF9485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8D21F-E96E-B947-B1D5-044ED282B3F2}" type="datetimeFigureOut">
              <a:rPr lang="en-US" smtClean="0"/>
              <a:t>2/2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503B47-3EBB-C14E-8E79-44CC56B81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148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503B47-3EBB-C14E-8E79-44CC56B8111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9804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82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56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33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8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306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07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8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845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999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0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446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4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pn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png"/><Relationship Id="rId5" Type="http://schemas.openxmlformats.org/officeDocument/2006/relationships/image" Target="../media/image3.tiff"/><Relationship Id="rId15" Type="http://schemas.openxmlformats.org/officeDocument/2006/relationships/image" Target="../media/image13.pn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CE4807-2F64-1F04-5269-AA4D7A4A5F18}"/>
              </a:ext>
            </a:extLst>
          </p:cNvPr>
          <p:cNvSpPr txBox="1"/>
          <p:nvPr/>
        </p:nvSpPr>
        <p:spPr>
          <a:xfrm>
            <a:off x="0" y="956744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948BB0-87E5-DBAC-EFE1-14146D4A6E4D}"/>
              </a:ext>
            </a:extLst>
          </p:cNvPr>
          <p:cNvSpPr txBox="1"/>
          <p:nvPr/>
        </p:nvSpPr>
        <p:spPr>
          <a:xfrm>
            <a:off x="58742" y="1043321"/>
            <a:ext cx="11095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Natural Fel d 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04E574E-5209-0323-A026-D69F0E01DF21}"/>
              </a:ext>
            </a:extLst>
          </p:cNvPr>
          <p:cNvSpPr txBox="1"/>
          <p:nvPr/>
        </p:nvSpPr>
        <p:spPr>
          <a:xfrm>
            <a:off x="118676" y="1911224"/>
            <a:ext cx="8883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el d 1 </a:t>
            </a:r>
            <a:r>
              <a:rPr lang="en-US" sz="1050" i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B58E5BE-7E77-976D-4615-474666C939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4565" y="674272"/>
            <a:ext cx="901145" cy="90114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9DD12AB-A059-FC3E-C129-6DED45A30E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04564" y="1613481"/>
            <a:ext cx="901145" cy="92363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30847AA-E421-F8EB-2026-9A4265B2E8CC}"/>
              </a:ext>
            </a:extLst>
          </p:cNvPr>
          <p:cNvSpPr txBox="1"/>
          <p:nvPr/>
        </p:nvSpPr>
        <p:spPr>
          <a:xfrm rot="16200000">
            <a:off x="1150027" y="2198233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386AD1FC-242F-BA20-E03C-DAC2532081A9}"/>
              </a:ext>
            </a:extLst>
          </p:cNvPr>
          <p:cNvCxnSpPr>
            <a:cxnSpLocks/>
          </p:cNvCxnSpPr>
          <p:nvPr/>
        </p:nvCxnSpPr>
        <p:spPr>
          <a:xfrm flipV="1">
            <a:off x="1402424" y="705407"/>
            <a:ext cx="0" cy="13392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7344B5F-1170-6C0B-2EB7-87A9031C183D}"/>
              </a:ext>
            </a:extLst>
          </p:cNvPr>
          <p:cNvCxnSpPr>
            <a:cxnSpLocks/>
          </p:cNvCxnSpPr>
          <p:nvPr/>
        </p:nvCxnSpPr>
        <p:spPr>
          <a:xfrm>
            <a:off x="1984320" y="2627029"/>
            <a:ext cx="16539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B3F6CA7F-F9DB-A821-5739-4A722164F8A1}"/>
              </a:ext>
            </a:extLst>
          </p:cNvPr>
          <p:cNvSpPr txBox="1"/>
          <p:nvPr/>
        </p:nvSpPr>
        <p:spPr>
          <a:xfrm>
            <a:off x="1429523" y="2497266"/>
            <a:ext cx="6062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294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0D9095CF-9F61-B5C4-B1BA-B147BBFA53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1925" y="671244"/>
            <a:ext cx="907200" cy="9072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F9D0CE13-60E6-F92D-05D3-97278D61B856}"/>
              </a:ext>
            </a:extLst>
          </p:cNvPr>
          <p:cNvSpPr txBox="1"/>
          <p:nvPr/>
        </p:nvSpPr>
        <p:spPr>
          <a:xfrm rot="16200000">
            <a:off x="2208176" y="2121134"/>
            <a:ext cx="6735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203c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77E3A3A-46EA-6D48-29A3-66B37BC6C9D5}"/>
              </a:ext>
            </a:extLst>
          </p:cNvPr>
          <p:cNvCxnSpPr>
            <a:cxnSpLocks/>
            <a:stCxn id="23" idx="3"/>
          </p:cNvCxnSpPr>
          <p:nvPr/>
        </p:nvCxnSpPr>
        <p:spPr>
          <a:xfrm flipV="1">
            <a:off x="2544967" y="705407"/>
            <a:ext cx="0" cy="120589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" name="Picture 24">
            <a:extLst>
              <a:ext uri="{FF2B5EF4-FFF2-40B4-BE49-F238E27FC236}">
                <a16:creationId xmlns:a16="http://schemas.microsoft.com/office/drawing/2014/main" id="{90E7E664-10F4-A0D4-0EFD-3AC8912AEEF2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681653" y="1625589"/>
            <a:ext cx="907200" cy="907200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DAFC6EAE-010E-CE85-F2F0-08E4DE4F6A50}"/>
              </a:ext>
            </a:extLst>
          </p:cNvPr>
          <p:cNvSpPr/>
          <p:nvPr/>
        </p:nvSpPr>
        <p:spPr>
          <a:xfrm>
            <a:off x="1201284" y="234375"/>
            <a:ext cx="2588049" cy="25459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5AEF42B-2252-3F40-8EB9-5B18A9969A9D}"/>
              </a:ext>
            </a:extLst>
          </p:cNvPr>
          <p:cNvSpPr/>
          <p:nvPr/>
        </p:nvSpPr>
        <p:spPr>
          <a:xfrm>
            <a:off x="1201283" y="221673"/>
            <a:ext cx="2588049" cy="274535"/>
          </a:xfrm>
          <a:prstGeom prst="rect">
            <a:avLst/>
          </a:prstGeom>
          <a:solidFill>
            <a:srgbClr val="00206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asophil Activatio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3DD96A5-4AF1-77A4-8AC9-BFA8F4090A12}"/>
              </a:ext>
            </a:extLst>
          </p:cNvPr>
          <p:cNvSpPr txBox="1"/>
          <p:nvPr/>
        </p:nvSpPr>
        <p:spPr>
          <a:xfrm>
            <a:off x="1567169" y="682922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53.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FD6AD83-93FE-2EEF-009B-0255E38582BE}"/>
              </a:ext>
            </a:extLst>
          </p:cNvPr>
          <p:cNvSpPr txBox="1"/>
          <p:nvPr/>
        </p:nvSpPr>
        <p:spPr>
          <a:xfrm>
            <a:off x="1603565" y="1601164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8.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A0CFF30-ADF6-B210-82D7-18C3B6656C0B}"/>
              </a:ext>
            </a:extLst>
          </p:cNvPr>
          <p:cNvSpPr txBox="1"/>
          <p:nvPr/>
        </p:nvSpPr>
        <p:spPr>
          <a:xfrm>
            <a:off x="2708989" y="160896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15.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4BC98D7-25AD-AE13-3572-B399B4D6C169}"/>
              </a:ext>
            </a:extLst>
          </p:cNvPr>
          <p:cNvSpPr txBox="1"/>
          <p:nvPr/>
        </p:nvSpPr>
        <p:spPr>
          <a:xfrm>
            <a:off x="2726711" y="695430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62.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4BA4E03-2707-737F-3EB8-3AE27B66D89D}"/>
              </a:ext>
            </a:extLst>
          </p:cNvPr>
          <p:cNvSpPr txBox="1"/>
          <p:nvPr/>
        </p:nvSpPr>
        <p:spPr>
          <a:xfrm rot="16200000">
            <a:off x="3821335" y="2182265"/>
            <a:ext cx="47641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DAO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AB8FAD61-E9A2-FA5B-95A0-655939F5D864}"/>
              </a:ext>
            </a:extLst>
          </p:cNvPr>
          <p:cNvCxnSpPr>
            <a:cxnSpLocks/>
          </p:cNvCxnSpPr>
          <p:nvPr/>
        </p:nvCxnSpPr>
        <p:spPr>
          <a:xfrm flipV="1">
            <a:off x="4046480" y="689439"/>
            <a:ext cx="0" cy="13392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51D3DB0E-5C61-86CC-D987-F6ECC32DC900}"/>
              </a:ext>
            </a:extLst>
          </p:cNvPr>
          <p:cNvSpPr txBox="1"/>
          <p:nvPr/>
        </p:nvSpPr>
        <p:spPr>
          <a:xfrm>
            <a:off x="4152426" y="2497266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5E4DBE1-355E-6903-E389-C9D815009D36}"/>
              </a:ext>
            </a:extLst>
          </p:cNvPr>
          <p:cNvSpPr/>
          <p:nvPr/>
        </p:nvSpPr>
        <p:spPr>
          <a:xfrm>
            <a:off x="3845340" y="218407"/>
            <a:ext cx="2588049" cy="254599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730207C-E4AF-B3C0-98A8-59A07EF20908}"/>
              </a:ext>
            </a:extLst>
          </p:cNvPr>
          <p:cNvSpPr/>
          <p:nvPr/>
        </p:nvSpPr>
        <p:spPr>
          <a:xfrm>
            <a:off x="3845339" y="205705"/>
            <a:ext cx="2588049" cy="274535"/>
          </a:xfrm>
          <a:prstGeom prst="rect">
            <a:avLst/>
          </a:prstGeom>
          <a:solidFill>
            <a:srgbClr val="00206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asophil Histamine Release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1419269A-415D-1A0E-D1B0-980C763E6F4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96380" y="672193"/>
            <a:ext cx="907200" cy="9072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2E01DC53-3580-3B00-F106-C07DAE3FC4EC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203249" y="1625308"/>
            <a:ext cx="907200" cy="9072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ECC50A70-A0C2-2CAA-95DA-5A8CFBEB955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09679" y="672230"/>
            <a:ext cx="907200" cy="9072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98F3D5A1-29BC-8BF4-DF02-A3828FD0A752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5310008" y="1640065"/>
            <a:ext cx="907200" cy="90720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2695697-C0C1-6F48-5C75-F79F498D7AAC}"/>
              </a:ext>
            </a:extLst>
          </p:cNvPr>
          <p:cNvSpPr txBox="1"/>
          <p:nvPr/>
        </p:nvSpPr>
        <p:spPr>
          <a:xfrm>
            <a:off x="5241913" y="2510761"/>
            <a:ext cx="6735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203c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32D1EFA-30DD-4582-DB56-BDD317FE823B}"/>
              </a:ext>
            </a:extLst>
          </p:cNvPr>
          <p:cNvSpPr txBox="1"/>
          <p:nvPr/>
        </p:nvSpPr>
        <p:spPr>
          <a:xfrm>
            <a:off x="4347546" y="2278155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070A2F3-2FFA-B983-3C03-C8698BFB2EB6}"/>
              </a:ext>
            </a:extLst>
          </p:cNvPr>
          <p:cNvSpPr txBox="1"/>
          <p:nvPr/>
        </p:nvSpPr>
        <p:spPr>
          <a:xfrm>
            <a:off x="5443186" y="2285655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199E3A2-CFEA-5FDC-44E0-ABB4D135758D}"/>
              </a:ext>
            </a:extLst>
          </p:cNvPr>
          <p:cNvSpPr txBox="1"/>
          <p:nvPr/>
        </p:nvSpPr>
        <p:spPr>
          <a:xfrm>
            <a:off x="4247621" y="1313807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22.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D6DE665-4614-9641-8B53-45B21E7CFFBA}"/>
              </a:ext>
            </a:extLst>
          </p:cNvPr>
          <p:cNvSpPr txBox="1"/>
          <p:nvPr/>
        </p:nvSpPr>
        <p:spPr>
          <a:xfrm>
            <a:off x="5338146" y="129266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18.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7115BB8-A438-9E6D-713C-0217ABC9FB03}"/>
              </a:ext>
            </a:extLst>
          </p:cNvPr>
          <p:cNvSpPr txBox="1"/>
          <p:nvPr/>
        </p:nvSpPr>
        <p:spPr>
          <a:xfrm>
            <a:off x="177799" y="60238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5DDE30A-630D-E15F-B946-C2261BE4D8FE}"/>
              </a:ext>
            </a:extLst>
          </p:cNvPr>
          <p:cNvSpPr txBox="1"/>
          <p:nvPr/>
        </p:nvSpPr>
        <p:spPr>
          <a:xfrm>
            <a:off x="3335353" y="2976503"/>
            <a:ext cx="462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pic>
        <p:nvPicPr>
          <p:cNvPr id="50" name="Picture 49" descr="A blue and orange rectangular objects&#10;&#10;Description automatically generated">
            <a:extLst>
              <a:ext uri="{FF2B5EF4-FFF2-40B4-BE49-F238E27FC236}">
                <a16:creationId xmlns:a16="http://schemas.microsoft.com/office/drawing/2014/main" id="{A9506290-89F5-1743-F182-8F2F2C168A9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31671"/>
          <a:stretch/>
        </p:blipFill>
        <p:spPr>
          <a:xfrm>
            <a:off x="3561801" y="3123287"/>
            <a:ext cx="1468907" cy="1561287"/>
          </a:xfrm>
          <a:prstGeom prst="rect">
            <a:avLst/>
          </a:prstGeom>
        </p:spPr>
      </p:pic>
      <p:graphicFrame>
        <p:nvGraphicFramePr>
          <p:cNvPr id="53" name="Table 28">
            <a:extLst>
              <a:ext uri="{FF2B5EF4-FFF2-40B4-BE49-F238E27FC236}">
                <a16:creationId xmlns:a16="http://schemas.microsoft.com/office/drawing/2014/main" id="{5F9B3544-008B-D3C6-F74E-32366FDAA3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44478"/>
              </p:ext>
            </p:extLst>
          </p:nvPr>
        </p:nvGraphicFramePr>
        <p:xfrm>
          <a:off x="708581" y="7207801"/>
          <a:ext cx="4355673" cy="1498137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256896">
                  <a:extLst>
                    <a:ext uri="{9D8B030D-6E8A-4147-A177-3AD203B41FA5}">
                      <a16:colId xmlns:a16="http://schemas.microsoft.com/office/drawing/2014/main" val="538048041"/>
                    </a:ext>
                  </a:extLst>
                </a:gridCol>
                <a:gridCol w="1121347">
                  <a:extLst>
                    <a:ext uri="{9D8B030D-6E8A-4147-A177-3AD203B41FA5}">
                      <a16:colId xmlns:a16="http://schemas.microsoft.com/office/drawing/2014/main" val="1048386575"/>
                    </a:ext>
                  </a:extLst>
                </a:gridCol>
                <a:gridCol w="1061059">
                  <a:extLst>
                    <a:ext uri="{9D8B030D-6E8A-4147-A177-3AD203B41FA5}">
                      <a16:colId xmlns:a16="http://schemas.microsoft.com/office/drawing/2014/main" val="4185910255"/>
                    </a:ext>
                  </a:extLst>
                </a:gridCol>
                <a:gridCol w="916371">
                  <a:extLst>
                    <a:ext uri="{9D8B030D-6E8A-4147-A177-3AD203B41FA5}">
                      <a16:colId xmlns:a16="http://schemas.microsoft.com/office/drawing/2014/main" val="929880482"/>
                    </a:ext>
                  </a:extLst>
                </a:gridCol>
              </a:tblGrid>
              <a:tr h="415582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tural Fel d 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ean ± SEM)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l d 1 </a:t>
                      </a:r>
                      <a:r>
                        <a:rPr lang="en-US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</a:t>
                      </a:r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ean ± SEM)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 </a:t>
                      </a:r>
                    </a:p>
                  </a:txBody>
                  <a:tcPr marL="113340" marR="113340" marT="56670" marB="56670" anchor="ctr"/>
                </a:tc>
                <a:extLst>
                  <a:ext uri="{0D108BD9-81ED-4DB2-BD59-A6C34878D82A}">
                    <a16:rowId xmlns:a16="http://schemas.microsoft.com/office/drawing/2014/main" val="1692911975"/>
                  </a:ext>
                </a:extLst>
              </a:tr>
              <a:tr h="282777"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3</a:t>
                      </a:r>
                      <a:r>
                        <a:rPr lang="en-US" sz="10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2 ± 14.6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 ± 3.0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-fold</a:t>
                      </a:r>
                    </a:p>
                  </a:txBody>
                  <a:tcPr marL="113340" marR="113340" marT="56670" marB="56670" anchor="ctr"/>
                </a:tc>
                <a:extLst>
                  <a:ext uri="{0D108BD9-81ED-4DB2-BD59-A6C34878D82A}">
                    <a16:rowId xmlns:a16="http://schemas.microsoft.com/office/drawing/2014/main" val="901660825"/>
                  </a:ext>
                </a:extLst>
              </a:tr>
              <a:tr h="264461"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3c</a:t>
                      </a:r>
                      <a:r>
                        <a:rPr lang="en-US" sz="10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ight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.1 ± 25.2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5 ± 15.4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-fold</a:t>
                      </a:r>
                    </a:p>
                  </a:txBody>
                  <a:tcPr marL="113340" marR="113340" marT="56670" marB="56670" anchor="ctr"/>
                </a:tc>
                <a:extLst>
                  <a:ext uri="{0D108BD9-81ED-4DB2-BD59-A6C34878D82A}">
                    <a16:rowId xmlns:a16="http://schemas.microsoft.com/office/drawing/2014/main" val="2901934465"/>
                  </a:ext>
                </a:extLst>
              </a:tr>
              <a:tr h="264461"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O</a:t>
                      </a:r>
                      <a:r>
                        <a:rPr lang="en-US" sz="10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63</a:t>
                      </a:r>
                      <a:r>
                        <a:rPr lang="en-US" sz="10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7 ± 13.1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 ± 3.9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-fold</a:t>
                      </a:r>
                    </a:p>
                  </a:txBody>
                  <a:tcPr marL="113340" marR="113340" marT="56670" marB="56670" anchor="ctr"/>
                </a:tc>
                <a:extLst>
                  <a:ext uri="{0D108BD9-81ED-4DB2-BD59-A6C34878D82A}">
                    <a16:rowId xmlns:a16="http://schemas.microsoft.com/office/drawing/2014/main" val="541995862"/>
                  </a:ext>
                </a:extLst>
              </a:tr>
              <a:tr h="264461">
                <a:tc>
                  <a:txBody>
                    <a:bodyPr/>
                    <a:lstStyle/>
                    <a:p>
                      <a:pPr algn="ctr"/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O</a:t>
                      </a:r>
                      <a:r>
                        <a:rPr lang="en-US" sz="10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3c</a:t>
                      </a:r>
                      <a:r>
                        <a:rPr lang="en-US" sz="1000" b="1" baseline="30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ight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3 ± 12.7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 ± 3.9</a:t>
                      </a:r>
                    </a:p>
                  </a:txBody>
                  <a:tcPr marL="113340" marR="113340" marT="56670" marB="5667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-fold</a:t>
                      </a:r>
                    </a:p>
                  </a:txBody>
                  <a:tcPr marL="113340" marR="113340" marT="56670" marB="56670" anchor="ctr"/>
                </a:tc>
                <a:extLst>
                  <a:ext uri="{0D108BD9-81ED-4DB2-BD59-A6C34878D82A}">
                    <a16:rowId xmlns:a16="http://schemas.microsoft.com/office/drawing/2014/main" val="776416116"/>
                  </a:ext>
                </a:extLst>
              </a:tr>
            </a:tbl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801FB3FA-3716-AFEE-FAFC-E258F3AC0702}"/>
              </a:ext>
            </a:extLst>
          </p:cNvPr>
          <p:cNvSpPr txBox="1"/>
          <p:nvPr/>
        </p:nvSpPr>
        <p:spPr>
          <a:xfrm>
            <a:off x="268384" y="6987678"/>
            <a:ext cx="462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9D75C0F-F0B5-7873-AA48-96154F77EA0D}"/>
              </a:ext>
            </a:extLst>
          </p:cNvPr>
          <p:cNvSpPr txBox="1"/>
          <p:nvPr/>
        </p:nvSpPr>
        <p:spPr>
          <a:xfrm>
            <a:off x="3361061" y="4702846"/>
            <a:ext cx="462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3512EC7B-F785-D93F-D360-1223B2A94AA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32610"/>
          <a:stretch/>
        </p:blipFill>
        <p:spPr>
          <a:xfrm>
            <a:off x="5022931" y="3124113"/>
            <a:ext cx="1485592" cy="1559634"/>
          </a:xfrm>
          <a:prstGeom prst="rect">
            <a:avLst/>
          </a:prstGeom>
        </p:spPr>
      </p:pic>
      <p:grpSp>
        <p:nvGrpSpPr>
          <p:cNvPr id="65" name="Group 64">
            <a:extLst>
              <a:ext uri="{FF2B5EF4-FFF2-40B4-BE49-F238E27FC236}">
                <a16:creationId xmlns:a16="http://schemas.microsoft.com/office/drawing/2014/main" id="{EDBEE97B-8B3B-4C9B-304A-EFF4DFEB6DC2}"/>
              </a:ext>
            </a:extLst>
          </p:cNvPr>
          <p:cNvGrpSpPr/>
          <p:nvPr/>
        </p:nvGrpSpPr>
        <p:grpSpPr>
          <a:xfrm>
            <a:off x="719958" y="2982299"/>
            <a:ext cx="2230223" cy="1878616"/>
            <a:chOff x="-1799602" y="2179139"/>
            <a:chExt cx="1728000" cy="1455571"/>
          </a:xfrm>
        </p:grpSpPr>
        <p:pic>
          <p:nvPicPr>
            <p:cNvPr id="57" name="Picture 56" descr="A graph of a graph with dots and lines&#10;&#10;Description automatically generated with medium confidence">
              <a:extLst>
                <a:ext uri="{FF2B5EF4-FFF2-40B4-BE49-F238E27FC236}">
                  <a16:creationId xmlns:a16="http://schemas.microsoft.com/office/drawing/2014/main" id="{08E6482C-952A-E1C7-4C40-7850E92A4E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b="12135"/>
            <a:stretch/>
          </p:blipFill>
          <p:spPr>
            <a:xfrm>
              <a:off x="-1799602" y="2179139"/>
              <a:ext cx="1728000" cy="1455571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5DC9C70-C503-BA9E-86D7-4CD25C73FEBD}"/>
                </a:ext>
              </a:extLst>
            </p:cNvPr>
            <p:cNvSpPr txBox="1"/>
            <p:nvPr/>
          </p:nvSpPr>
          <p:spPr>
            <a:xfrm>
              <a:off x="-551034" y="2338225"/>
              <a:ext cx="310588" cy="2473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59F3B83-D398-DB44-9105-69B4C53834AD}"/>
                </a:ext>
              </a:extLst>
            </p:cNvPr>
            <p:cNvSpPr txBox="1"/>
            <p:nvPr/>
          </p:nvSpPr>
          <p:spPr>
            <a:xfrm>
              <a:off x="-323261" y="2357271"/>
              <a:ext cx="193473" cy="2473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0729E7E6-B0F6-8445-46FA-C432A13B2274}"/>
              </a:ext>
            </a:extLst>
          </p:cNvPr>
          <p:cNvGrpSpPr/>
          <p:nvPr/>
        </p:nvGrpSpPr>
        <p:grpSpPr>
          <a:xfrm>
            <a:off x="713353" y="4724109"/>
            <a:ext cx="2236828" cy="2115598"/>
            <a:chOff x="2789648" y="2976744"/>
            <a:chExt cx="2299186" cy="2174576"/>
          </a:xfrm>
        </p:grpSpPr>
        <p:pic>
          <p:nvPicPr>
            <p:cNvPr id="60" name="Picture 59" descr="A graph of a line with dots and lines&#10;&#10;Description automatically generated with medium confidence">
              <a:extLst>
                <a:ext uri="{FF2B5EF4-FFF2-40B4-BE49-F238E27FC236}">
                  <a16:creationId xmlns:a16="http://schemas.microsoft.com/office/drawing/2014/main" id="{E05E99F9-B126-2D51-A55A-54D7F90278F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789648" y="2976744"/>
              <a:ext cx="2286572" cy="2174576"/>
            </a:xfrm>
            <a:prstGeom prst="rect">
              <a:avLst/>
            </a:prstGeom>
          </p:spPr>
        </p:pic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6672398-22D0-072F-35E8-D7F7FF1D7467}"/>
                </a:ext>
              </a:extLst>
            </p:cNvPr>
            <p:cNvSpPr txBox="1"/>
            <p:nvPr/>
          </p:nvSpPr>
          <p:spPr>
            <a:xfrm>
              <a:off x="4094812" y="4052012"/>
              <a:ext cx="3228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9C9C09E-9D12-EE64-17D7-7E02667461C9}"/>
                </a:ext>
              </a:extLst>
            </p:cNvPr>
            <p:cNvSpPr txBox="1"/>
            <p:nvPr/>
          </p:nvSpPr>
          <p:spPr>
            <a:xfrm>
              <a:off x="4272584" y="3944210"/>
              <a:ext cx="4013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144366E-CD65-7E51-9971-EFDD2ECEE5B7}"/>
                </a:ext>
              </a:extLst>
            </p:cNvPr>
            <p:cNvSpPr txBox="1"/>
            <p:nvPr/>
          </p:nvSpPr>
          <p:spPr>
            <a:xfrm>
              <a:off x="4444827" y="3671640"/>
              <a:ext cx="4798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0C61A6B-DA55-4839-7EDD-33B47032B285}"/>
                </a:ext>
              </a:extLst>
            </p:cNvPr>
            <p:cNvSpPr txBox="1"/>
            <p:nvPr/>
          </p:nvSpPr>
          <p:spPr>
            <a:xfrm>
              <a:off x="4687509" y="3763710"/>
              <a:ext cx="4013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6C277716-4B7A-ECE4-FA48-6CDA347321E9}"/>
              </a:ext>
            </a:extLst>
          </p:cNvPr>
          <p:cNvSpPr txBox="1"/>
          <p:nvPr/>
        </p:nvSpPr>
        <p:spPr>
          <a:xfrm>
            <a:off x="266231" y="2976503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9D1E04BF-AB37-1B72-8C43-112F8D6547FF}"/>
              </a:ext>
            </a:extLst>
          </p:cNvPr>
          <p:cNvGrpSpPr/>
          <p:nvPr/>
        </p:nvGrpSpPr>
        <p:grpSpPr>
          <a:xfrm>
            <a:off x="3530150" y="2624224"/>
            <a:ext cx="2686729" cy="4682692"/>
            <a:chOff x="3530150" y="2624224"/>
            <a:chExt cx="2686729" cy="4682692"/>
          </a:xfrm>
        </p:grpSpPr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A9F6E0EA-4D50-3762-8CB3-C9EAE1652D2C}"/>
                </a:ext>
              </a:extLst>
            </p:cNvPr>
            <p:cNvCxnSpPr>
              <a:cxnSpLocks/>
            </p:cNvCxnSpPr>
            <p:nvPr/>
          </p:nvCxnSpPr>
          <p:spPr>
            <a:xfrm>
              <a:off x="4649980" y="2624224"/>
              <a:ext cx="4536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1301B1D4-8B44-A768-1416-7CF5F1DF9485}"/>
                </a:ext>
              </a:extLst>
            </p:cNvPr>
            <p:cNvCxnSpPr>
              <a:cxnSpLocks/>
            </p:cNvCxnSpPr>
            <p:nvPr/>
          </p:nvCxnSpPr>
          <p:spPr>
            <a:xfrm>
              <a:off x="5847442" y="2635998"/>
              <a:ext cx="36943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51" name="Picture 50" descr="A blue and orange rectangular object with a black background&#10;&#10;Description automatically generated">
              <a:extLst>
                <a:ext uri="{FF2B5EF4-FFF2-40B4-BE49-F238E27FC236}">
                  <a16:creationId xmlns:a16="http://schemas.microsoft.com/office/drawing/2014/main" id="{1D7A4CB7-EC27-1760-4963-58C5CC60F90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 b="32955"/>
            <a:stretch>
              <a:fillRect/>
            </a:stretch>
          </p:blipFill>
          <p:spPr>
            <a:xfrm>
              <a:off x="3530150" y="4825312"/>
              <a:ext cx="1468906" cy="1498137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BF09CFA-E68E-DE04-22D0-D698969AB4CD}"/>
                </a:ext>
              </a:extLst>
            </p:cNvPr>
            <p:cNvSpPr txBox="1"/>
            <p:nvPr/>
          </p:nvSpPr>
          <p:spPr>
            <a:xfrm rot="18660727">
              <a:off x="3385934" y="6572740"/>
              <a:ext cx="1191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atural Fel d 1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3434AD2C-E8DA-FF52-C117-4AB3F0B40AFC}"/>
                </a:ext>
              </a:extLst>
            </p:cNvPr>
            <p:cNvSpPr txBox="1"/>
            <p:nvPr/>
          </p:nvSpPr>
          <p:spPr>
            <a:xfrm rot="18660727">
              <a:off x="3931063" y="6488846"/>
              <a:ext cx="9877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l d 1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22215910-669C-7611-6A66-F44E15F566AB}"/>
              </a:ext>
            </a:extLst>
          </p:cNvPr>
          <p:cNvGrpSpPr/>
          <p:nvPr/>
        </p:nvGrpSpPr>
        <p:grpSpPr>
          <a:xfrm>
            <a:off x="5004900" y="4831358"/>
            <a:ext cx="1468906" cy="2482642"/>
            <a:chOff x="5004900" y="4831358"/>
            <a:chExt cx="1468906" cy="2482642"/>
          </a:xfrm>
        </p:grpSpPr>
        <p:pic>
          <p:nvPicPr>
            <p:cNvPr id="52" name="Picture 51" descr="A blue and orange rectangular object with a black background&#10;&#10;Description automatically generated">
              <a:extLst>
                <a:ext uri="{FF2B5EF4-FFF2-40B4-BE49-F238E27FC236}">
                  <a16:creationId xmlns:a16="http://schemas.microsoft.com/office/drawing/2014/main" id="{0EEDB0D0-1BEF-D362-821A-48A5437977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b="32281"/>
            <a:stretch>
              <a:fillRect/>
            </a:stretch>
          </p:blipFill>
          <p:spPr>
            <a:xfrm>
              <a:off x="5004900" y="4831358"/>
              <a:ext cx="1468906" cy="1492091"/>
            </a:xfrm>
            <a:prstGeom prst="rect">
              <a:avLst/>
            </a:prstGeom>
          </p:spPr>
        </p:pic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76F4CC5-A765-FC3C-2AB6-6D31A1DBAD54}"/>
                </a:ext>
              </a:extLst>
            </p:cNvPr>
            <p:cNvSpPr txBox="1"/>
            <p:nvPr/>
          </p:nvSpPr>
          <p:spPr>
            <a:xfrm rot="18660727">
              <a:off x="4876480" y="6579824"/>
              <a:ext cx="11913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atural Fel d 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6917CC5-746C-D3BC-3A5D-D0ABC9E28CC2}"/>
                </a:ext>
              </a:extLst>
            </p:cNvPr>
            <p:cNvSpPr txBox="1"/>
            <p:nvPr/>
          </p:nvSpPr>
          <p:spPr>
            <a:xfrm rot="18660727">
              <a:off x="5421609" y="6495930"/>
              <a:ext cx="9877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l d 1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78941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745</TotalTime>
  <Words>118</Words>
  <Application>Microsoft Macintosh PowerPoint</Application>
  <PresentationFormat>A4 Paper (210x297 mm)</PresentationFormat>
  <Paragraphs>5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yhadi, Janice A</dc:creator>
  <cp:lastModifiedBy>Layhadi, Janice A</cp:lastModifiedBy>
  <cp:revision>42</cp:revision>
  <cp:lastPrinted>2023-09-27T12:15:59Z</cp:lastPrinted>
  <dcterms:created xsi:type="dcterms:W3CDTF">2023-09-26T16:40:01Z</dcterms:created>
  <dcterms:modified xsi:type="dcterms:W3CDTF">2026-02-02T16:38:44Z</dcterms:modified>
</cp:coreProperties>
</file>